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6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4" d="100"/>
          <a:sy n="54" d="100"/>
        </p:scale>
        <p:origin x="264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psgams01\metabolomics$\Data\Jules\korea\Plos%20ONE\supplemental%20Table%20S4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P$3</c:f>
              <c:strCache>
                <c:ptCount val="1"/>
                <c:pt idx="0">
                  <c:v>PRO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P$13:$P$18</c:f>
                <c:numCache>
                  <c:formatCode>General</c:formatCode>
                  <c:ptCount val="6"/>
                  <c:pt idx="0">
                    <c:v>196.83383666322041</c:v>
                  </c:pt>
                  <c:pt idx="1">
                    <c:v>396.93325112832576</c:v>
                  </c:pt>
                  <c:pt idx="2">
                    <c:v>5234.1005404510279</c:v>
                  </c:pt>
                  <c:pt idx="3">
                    <c:v>1897.1626083027359</c:v>
                  </c:pt>
                  <c:pt idx="4">
                    <c:v>1741.9543922507441</c:v>
                  </c:pt>
                  <c:pt idx="5">
                    <c:v>3065.2762389029294</c:v>
                  </c:pt>
                </c:numCache>
              </c:numRef>
            </c:plus>
            <c:minus>
              <c:numRef>
                <c:f>hybrids!$P$13:$P$18</c:f>
                <c:numCache>
                  <c:formatCode>General</c:formatCode>
                  <c:ptCount val="6"/>
                  <c:pt idx="0">
                    <c:v>196.83383666322041</c:v>
                  </c:pt>
                  <c:pt idx="1">
                    <c:v>396.93325112832576</c:v>
                  </c:pt>
                  <c:pt idx="2">
                    <c:v>5234.1005404510279</c:v>
                  </c:pt>
                  <c:pt idx="3">
                    <c:v>1897.1626083027359</c:v>
                  </c:pt>
                  <c:pt idx="4">
                    <c:v>1741.9543922507441</c:v>
                  </c:pt>
                  <c:pt idx="5">
                    <c:v>3065.27623890292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P$4:$P$9</c:f>
              <c:numCache>
                <c:formatCode>0</c:formatCode>
                <c:ptCount val="6"/>
                <c:pt idx="0">
                  <c:v>9693.4781333333322</c:v>
                </c:pt>
                <c:pt idx="1">
                  <c:v>2783.8672666666666</c:v>
                </c:pt>
                <c:pt idx="2">
                  <c:v>8955.1990666666679</c:v>
                </c:pt>
                <c:pt idx="3">
                  <c:v>9293.6180333333323</c:v>
                </c:pt>
                <c:pt idx="4">
                  <c:v>6328.837966666666</c:v>
                </c:pt>
                <c:pt idx="5">
                  <c:v>7175.820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3F-4725-B3F7-55B0854E9A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3.7414465964472753E-2"/>
              <c:y val="0.169042031085710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Y$3</c:f>
              <c:strCache>
                <c:ptCount val="1"/>
                <c:pt idx="0">
                  <c:v>4MBR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Y$13:$Y$18</c:f>
                <c:numCache>
                  <c:formatCode>General</c:formatCode>
                  <c:ptCount val="6"/>
                  <c:pt idx="0">
                    <c:v>410.42055487393657</c:v>
                  </c:pt>
                  <c:pt idx="1">
                    <c:v>143.8773319481912</c:v>
                  </c:pt>
                  <c:pt idx="2">
                    <c:v>30.754743178735861</c:v>
                  </c:pt>
                  <c:pt idx="3">
                    <c:v>42.583256258103766</c:v>
                  </c:pt>
                  <c:pt idx="4">
                    <c:v>419.37053798463609</c:v>
                  </c:pt>
                  <c:pt idx="5">
                    <c:v>459.82061653699668</c:v>
                  </c:pt>
                </c:numCache>
              </c:numRef>
            </c:plus>
            <c:minus>
              <c:numRef>
                <c:f>hybrids!$Y$13:$Y$18</c:f>
                <c:numCache>
                  <c:formatCode>General</c:formatCode>
                  <c:ptCount val="6"/>
                  <c:pt idx="0">
                    <c:v>410.42055487393657</c:v>
                  </c:pt>
                  <c:pt idx="1">
                    <c:v>143.8773319481912</c:v>
                  </c:pt>
                  <c:pt idx="2">
                    <c:v>30.754743178735861</c:v>
                  </c:pt>
                  <c:pt idx="3">
                    <c:v>42.583256258103766</c:v>
                  </c:pt>
                  <c:pt idx="4">
                    <c:v>419.37053798463609</c:v>
                  </c:pt>
                  <c:pt idx="5">
                    <c:v>459.820616536996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Y$4:$Y$9</c:f>
              <c:numCache>
                <c:formatCode>0</c:formatCode>
                <c:ptCount val="6"/>
                <c:pt idx="0">
                  <c:v>1043.2683999999999</c:v>
                </c:pt>
                <c:pt idx="1">
                  <c:v>829.04229999999995</c:v>
                </c:pt>
                <c:pt idx="2">
                  <c:v>1432.7245</c:v>
                </c:pt>
                <c:pt idx="3">
                  <c:v>2108.8762333333334</c:v>
                </c:pt>
                <c:pt idx="4">
                  <c:v>1667.9526333333333</c:v>
                </c:pt>
                <c:pt idx="5">
                  <c:v>2001.3951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ED-4EA3-ACBF-326607C71F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 dirty="0" err="1"/>
                  <a:t>Relative</a:t>
                </a:r>
                <a:r>
                  <a:rPr lang="nl-NL" sz="700" dirty="0"/>
                  <a:t> </a:t>
                </a:r>
                <a:r>
                  <a:rPr lang="nl-NL" sz="700" dirty="0" err="1"/>
                  <a:t>abundance</a:t>
                </a:r>
                <a:r>
                  <a:rPr lang="nl-NL" sz="700" dirty="0"/>
                  <a:t> (</a:t>
                </a:r>
                <a:r>
                  <a:rPr lang="nl-NL" sz="700" dirty="0" err="1"/>
                  <a:t>mass</a:t>
                </a:r>
                <a:r>
                  <a:rPr lang="nl-NL" sz="700" dirty="0"/>
                  <a:t> </a:t>
                </a:r>
                <a:r>
                  <a:rPr lang="nl-NL" sz="700" dirty="0" err="1"/>
                  <a:t>counts</a:t>
                </a:r>
                <a:r>
                  <a:rPr lang="nl-NL" sz="700" dirty="0"/>
                  <a:t>)</a:t>
                </a:r>
              </a:p>
            </c:rich>
          </c:tx>
          <c:layout>
            <c:manualLayout>
              <c:xMode val="edge"/>
              <c:yMode val="edge"/>
              <c:x val="4.4416112525057588E-2"/>
              <c:y val="0.1777939341726723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Z$3</c:f>
              <c:strCache>
                <c:ptCount val="1"/>
                <c:pt idx="0">
                  <c:v>NBR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Z$13:$Z$18</c:f>
                <c:numCache>
                  <c:formatCode>General</c:formatCode>
                  <c:ptCount val="6"/>
                  <c:pt idx="0">
                    <c:v>1672.3214190715792</c:v>
                  </c:pt>
                  <c:pt idx="1">
                    <c:v>2183.5163559854113</c:v>
                  </c:pt>
                  <c:pt idx="2">
                    <c:v>475.55119264555526</c:v>
                  </c:pt>
                  <c:pt idx="3">
                    <c:v>1303.7504005437602</c:v>
                  </c:pt>
                  <c:pt idx="4">
                    <c:v>1358.9912756618942</c:v>
                  </c:pt>
                  <c:pt idx="5">
                    <c:v>1332.8017330184148</c:v>
                  </c:pt>
                </c:numCache>
              </c:numRef>
            </c:plus>
            <c:minus>
              <c:numRef>
                <c:f>hybrids!$Z$13:$Z$18</c:f>
                <c:numCache>
                  <c:formatCode>General</c:formatCode>
                  <c:ptCount val="6"/>
                  <c:pt idx="0">
                    <c:v>1672.3214190715792</c:v>
                  </c:pt>
                  <c:pt idx="1">
                    <c:v>2183.5163559854113</c:v>
                  </c:pt>
                  <c:pt idx="2">
                    <c:v>475.55119264555526</c:v>
                  </c:pt>
                  <c:pt idx="3">
                    <c:v>1303.7504005437602</c:v>
                  </c:pt>
                  <c:pt idx="4">
                    <c:v>1358.9912756618942</c:v>
                  </c:pt>
                  <c:pt idx="5">
                    <c:v>1332.80173301841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Z$4:$Z$9</c:f>
              <c:numCache>
                <c:formatCode>0</c:formatCode>
                <c:ptCount val="6"/>
                <c:pt idx="0">
                  <c:v>6605.4451333333336</c:v>
                </c:pt>
                <c:pt idx="1">
                  <c:v>7440.2663000000002</c:v>
                </c:pt>
                <c:pt idx="2">
                  <c:v>3200.9546</c:v>
                </c:pt>
                <c:pt idx="3">
                  <c:v>5354.2445666666663</c:v>
                </c:pt>
                <c:pt idx="4">
                  <c:v>3512.6458666666663</c:v>
                </c:pt>
                <c:pt idx="5">
                  <c:v>4452.8365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131-4D25-9463-BDD12C8F1B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4.3660206706232753E-2"/>
              <c:y val="0.1707076872945267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Q$3</c:f>
              <c:strCache>
                <c:ptCount val="1"/>
                <c:pt idx="0">
                  <c:v>NAP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Q$13:$Q$18</c:f>
                <c:numCache>
                  <c:formatCode>General</c:formatCode>
                  <c:ptCount val="6"/>
                  <c:pt idx="0">
                    <c:v>1877.4154823399722</c:v>
                  </c:pt>
                  <c:pt idx="1">
                    <c:v>5.4083886463529964</c:v>
                  </c:pt>
                  <c:pt idx="2">
                    <c:v>554.61258914662517</c:v>
                  </c:pt>
                  <c:pt idx="3">
                    <c:v>702.89342304304841</c:v>
                  </c:pt>
                  <c:pt idx="4">
                    <c:v>610.56405098965968</c:v>
                  </c:pt>
                  <c:pt idx="5">
                    <c:v>383.68075034474947</c:v>
                  </c:pt>
                </c:numCache>
              </c:numRef>
            </c:plus>
            <c:minus>
              <c:numRef>
                <c:f>hybrids!$Q$13:$Q$18</c:f>
                <c:numCache>
                  <c:formatCode>General</c:formatCode>
                  <c:ptCount val="6"/>
                  <c:pt idx="0">
                    <c:v>1877.4154823399722</c:v>
                  </c:pt>
                  <c:pt idx="1">
                    <c:v>5.4083886463529964</c:v>
                  </c:pt>
                  <c:pt idx="2">
                    <c:v>554.61258914662517</c:v>
                  </c:pt>
                  <c:pt idx="3">
                    <c:v>702.89342304304841</c:v>
                  </c:pt>
                  <c:pt idx="4">
                    <c:v>610.56405098965968</c:v>
                  </c:pt>
                  <c:pt idx="5">
                    <c:v>383.680750344749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Q$4:$Q$9</c:f>
              <c:numCache>
                <c:formatCode>0</c:formatCode>
                <c:ptCount val="6"/>
                <c:pt idx="0">
                  <c:v>6519.6846666666661</c:v>
                </c:pt>
                <c:pt idx="1">
                  <c:v>24.589700000000001</c:v>
                </c:pt>
                <c:pt idx="2">
                  <c:v>713.17533333333336</c:v>
                </c:pt>
                <c:pt idx="3">
                  <c:v>2630.4318666666668</c:v>
                </c:pt>
                <c:pt idx="4">
                  <c:v>2298.3965333333331</c:v>
                </c:pt>
                <c:pt idx="5">
                  <c:v>2889.8130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C6-4B09-B965-11968F0CE8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3.5859341028921514E-2"/>
              <c:y val="0.1384323378153235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R$3</c:f>
              <c:strCache>
                <c:ptCount val="1"/>
                <c:pt idx="0">
                  <c:v>NAP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R$13:$R$18</c:f>
                <c:numCache>
                  <c:formatCode>General</c:formatCode>
                  <c:ptCount val="6"/>
                  <c:pt idx="0">
                    <c:v>1154.0698556957864</c:v>
                  </c:pt>
                  <c:pt idx="1">
                    <c:v>3387.0887596880839</c:v>
                  </c:pt>
                  <c:pt idx="2">
                    <c:v>8903.6893916702429</c:v>
                  </c:pt>
                  <c:pt idx="3">
                    <c:v>1924.9534136053603</c:v>
                  </c:pt>
                  <c:pt idx="4">
                    <c:v>516.56842788494635</c:v>
                  </c:pt>
                  <c:pt idx="5">
                    <c:v>3143.0588601523841</c:v>
                  </c:pt>
                </c:numCache>
              </c:numRef>
            </c:plus>
            <c:minus>
              <c:numRef>
                <c:f>hybrids!$R$13:$R$18</c:f>
                <c:numCache>
                  <c:formatCode>General</c:formatCode>
                  <c:ptCount val="6"/>
                  <c:pt idx="0">
                    <c:v>1154.0698556957864</c:v>
                  </c:pt>
                  <c:pt idx="1">
                    <c:v>3387.0887596880839</c:v>
                  </c:pt>
                  <c:pt idx="2">
                    <c:v>8903.6893916702429</c:v>
                  </c:pt>
                  <c:pt idx="3">
                    <c:v>1924.9534136053603</c:v>
                  </c:pt>
                  <c:pt idx="4">
                    <c:v>516.56842788494635</c:v>
                  </c:pt>
                  <c:pt idx="5">
                    <c:v>3143.05886015238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R$4:$R$9</c:f>
              <c:numCache>
                <c:formatCode>0</c:formatCode>
                <c:ptCount val="6"/>
                <c:pt idx="0">
                  <c:v>1623.7488666666666</c:v>
                </c:pt>
                <c:pt idx="1">
                  <c:v>18104.648033333335</c:v>
                </c:pt>
                <c:pt idx="2">
                  <c:v>13749.4038</c:v>
                </c:pt>
                <c:pt idx="3">
                  <c:v>6049.3648999999996</c:v>
                </c:pt>
                <c:pt idx="4">
                  <c:v>4164.8951333333334</c:v>
                </c:pt>
                <c:pt idx="5">
                  <c:v>4694.1262666666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8E-4C38-B334-884AF53B90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4.1155912560920029E-2"/>
              <c:y val="0.161389607768113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T$3</c:f>
              <c:strCache>
                <c:ptCount val="1"/>
                <c:pt idx="0">
                  <c:v>CA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T$13:$T$18</c:f>
                <c:numCache>
                  <c:formatCode>General</c:formatCode>
                  <c:ptCount val="6"/>
                  <c:pt idx="0">
                    <c:v>4527.2012298863547</c:v>
                  </c:pt>
                  <c:pt idx="1">
                    <c:v>377.31207115645498</c:v>
                  </c:pt>
                  <c:pt idx="2">
                    <c:v>1727.2112911716215</c:v>
                  </c:pt>
                  <c:pt idx="3">
                    <c:v>2691.7287311517853</c:v>
                  </c:pt>
                  <c:pt idx="4">
                    <c:v>2407.1894502025179</c:v>
                  </c:pt>
                  <c:pt idx="5">
                    <c:v>4412.0012133147384</c:v>
                  </c:pt>
                </c:numCache>
              </c:numRef>
            </c:plus>
            <c:minus>
              <c:numRef>
                <c:f>hybrids!$T$13:$T$18</c:f>
                <c:numCache>
                  <c:formatCode>General</c:formatCode>
                  <c:ptCount val="6"/>
                  <c:pt idx="0">
                    <c:v>4527.2012298863547</c:v>
                  </c:pt>
                  <c:pt idx="1">
                    <c:v>377.31207115645498</c:v>
                  </c:pt>
                  <c:pt idx="2">
                    <c:v>1727.2112911716215</c:v>
                  </c:pt>
                  <c:pt idx="3">
                    <c:v>2691.7287311517853</c:v>
                  </c:pt>
                  <c:pt idx="4">
                    <c:v>2407.1894502025179</c:v>
                  </c:pt>
                  <c:pt idx="5">
                    <c:v>4412.00121331473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T$4:$T$9</c:f>
              <c:numCache>
                <c:formatCode>0</c:formatCode>
                <c:ptCount val="6"/>
                <c:pt idx="0">
                  <c:v>11421.028</c:v>
                </c:pt>
                <c:pt idx="1">
                  <c:v>2258.866133333333</c:v>
                </c:pt>
                <c:pt idx="2">
                  <c:v>7434.34</c:v>
                </c:pt>
                <c:pt idx="3">
                  <c:v>12540.874</c:v>
                </c:pt>
                <c:pt idx="4">
                  <c:v>10020.801533333333</c:v>
                </c:pt>
                <c:pt idx="5">
                  <c:v>11565.6176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9A1-4F72-9EC0-390EEC81F7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3.984371225435724E-2"/>
              <c:y val="0.212412592152952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U$3</c:f>
              <c:strCache>
                <c:ptCount val="1"/>
                <c:pt idx="0">
                  <c:v>ERU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U$13:$U$18</c:f>
                <c:numCache>
                  <c:formatCode>General</c:formatCode>
                  <c:ptCount val="6"/>
                  <c:pt idx="0">
                    <c:v>263.18951550603856</c:v>
                  </c:pt>
                  <c:pt idx="1">
                    <c:v>1631.8913252435775</c:v>
                  </c:pt>
                  <c:pt idx="2">
                    <c:v>3303.2398145992993</c:v>
                  </c:pt>
                  <c:pt idx="3">
                    <c:v>781.40845698155999</c:v>
                  </c:pt>
                  <c:pt idx="4">
                    <c:v>224.23528500010875</c:v>
                  </c:pt>
                  <c:pt idx="5">
                    <c:v>397.33337593834619</c:v>
                  </c:pt>
                </c:numCache>
              </c:numRef>
            </c:plus>
            <c:minus>
              <c:numRef>
                <c:f>hybrids!$U$13:$U$18</c:f>
                <c:numCache>
                  <c:formatCode>General</c:formatCode>
                  <c:ptCount val="6"/>
                  <c:pt idx="0">
                    <c:v>263.18951550603856</c:v>
                  </c:pt>
                  <c:pt idx="1">
                    <c:v>1631.8913252435775</c:v>
                  </c:pt>
                  <c:pt idx="2">
                    <c:v>3303.2398145992993</c:v>
                  </c:pt>
                  <c:pt idx="3">
                    <c:v>781.40845698155999</c:v>
                  </c:pt>
                  <c:pt idx="4">
                    <c:v>224.23528500010875</c:v>
                  </c:pt>
                  <c:pt idx="5">
                    <c:v>397.333375938346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U$4:$U$9</c:f>
              <c:numCache>
                <c:formatCode>0</c:formatCode>
                <c:ptCount val="6"/>
                <c:pt idx="0">
                  <c:v>3008.8284666666668</c:v>
                </c:pt>
                <c:pt idx="1">
                  <c:v>6668.6134333333339</c:v>
                </c:pt>
                <c:pt idx="2">
                  <c:v>4337.507466666666</c:v>
                </c:pt>
                <c:pt idx="3">
                  <c:v>3211.4789333333333</c:v>
                </c:pt>
                <c:pt idx="4">
                  <c:v>2219.1729</c:v>
                </c:pt>
                <c:pt idx="5">
                  <c:v>1563.6420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4D-4051-81B8-7B5BED06F0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4.1155912560920029E-2"/>
              <c:y val="0.146084761132920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X$3</c:f>
              <c:strCache>
                <c:ptCount val="1"/>
                <c:pt idx="0">
                  <c:v>BE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X$13:$X$18</c:f>
                <c:numCache>
                  <c:formatCode>General</c:formatCode>
                  <c:ptCount val="6"/>
                  <c:pt idx="0">
                    <c:v>2948.1200525465715</c:v>
                  </c:pt>
                  <c:pt idx="1">
                    <c:v>323.79701506485509</c:v>
                  </c:pt>
                  <c:pt idx="2">
                    <c:v>3310.5886283475475</c:v>
                  </c:pt>
                  <c:pt idx="3">
                    <c:v>3899.5748511148645</c:v>
                  </c:pt>
                  <c:pt idx="4">
                    <c:v>1963.5984930439624</c:v>
                  </c:pt>
                  <c:pt idx="5">
                    <c:v>3197.8352675574142</c:v>
                  </c:pt>
                </c:numCache>
              </c:numRef>
            </c:plus>
            <c:minus>
              <c:numRef>
                <c:f>hybrids!$X$13:$X$18</c:f>
                <c:numCache>
                  <c:formatCode>General</c:formatCode>
                  <c:ptCount val="6"/>
                  <c:pt idx="0">
                    <c:v>2948.1200525465715</c:v>
                  </c:pt>
                  <c:pt idx="1">
                    <c:v>323.79701506485509</c:v>
                  </c:pt>
                  <c:pt idx="2">
                    <c:v>3310.5886283475475</c:v>
                  </c:pt>
                  <c:pt idx="3">
                    <c:v>3899.5748511148645</c:v>
                  </c:pt>
                  <c:pt idx="4">
                    <c:v>1963.5984930439624</c:v>
                  </c:pt>
                  <c:pt idx="5">
                    <c:v>3197.83526755741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X$4:$X$9</c:f>
              <c:numCache>
                <c:formatCode>0</c:formatCode>
                <c:ptCount val="6"/>
                <c:pt idx="0">
                  <c:v>18550.316766666667</c:v>
                </c:pt>
                <c:pt idx="1">
                  <c:v>1294.9183</c:v>
                </c:pt>
                <c:pt idx="2">
                  <c:v>5172.2673333333332</c:v>
                </c:pt>
                <c:pt idx="3">
                  <c:v>13084.759966666667</c:v>
                </c:pt>
                <c:pt idx="4">
                  <c:v>10390.823066666668</c:v>
                </c:pt>
                <c:pt idx="5">
                  <c:v>9235.4650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545-495F-9E8F-F617D41D92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4.3828083479792966E-2"/>
              <c:y val="0.212412592152952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S$3</c:f>
              <c:strCache>
                <c:ptCount val="1"/>
                <c:pt idx="0">
                  <c:v>4HBR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S$13:$S$18</c:f>
                <c:numCache>
                  <c:formatCode>General</c:formatCode>
                  <c:ptCount val="6"/>
                  <c:pt idx="0">
                    <c:v>1744.5759288773104</c:v>
                  </c:pt>
                  <c:pt idx="1">
                    <c:v>252.12950143519501</c:v>
                  </c:pt>
                  <c:pt idx="2">
                    <c:v>26.065147659086836</c:v>
                  </c:pt>
                  <c:pt idx="3">
                    <c:v>289.35525169998806</c:v>
                  </c:pt>
                  <c:pt idx="4">
                    <c:v>1155.3462798310168</c:v>
                  </c:pt>
                  <c:pt idx="5">
                    <c:v>443.79341431094167</c:v>
                  </c:pt>
                </c:numCache>
              </c:numRef>
            </c:plus>
            <c:minus>
              <c:numRef>
                <c:f>hybrids!$S$13:$S$18</c:f>
                <c:numCache>
                  <c:formatCode>General</c:formatCode>
                  <c:ptCount val="6"/>
                  <c:pt idx="0">
                    <c:v>1744.5759288773104</c:v>
                  </c:pt>
                  <c:pt idx="1">
                    <c:v>252.12950143519501</c:v>
                  </c:pt>
                  <c:pt idx="2">
                    <c:v>26.065147659086836</c:v>
                  </c:pt>
                  <c:pt idx="3">
                    <c:v>289.35525169998806</c:v>
                  </c:pt>
                  <c:pt idx="4">
                    <c:v>1155.3462798310168</c:v>
                  </c:pt>
                  <c:pt idx="5">
                    <c:v>443.793414310941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S$4:$S$9</c:f>
              <c:numCache>
                <c:formatCode>0</c:formatCode>
                <c:ptCount val="6"/>
                <c:pt idx="0">
                  <c:v>6308.1458000000002</c:v>
                </c:pt>
                <c:pt idx="1">
                  <c:v>829.22370000000001</c:v>
                </c:pt>
                <c:pt idx="2">
                  <c:v>1637.4648999999999</c:v>
                </c:pt>
                <c:pt idx="3">
                  <c:v>1157.9286333333334</c:v>
                </c:pt>
                <c:pt idx="4">
                  <c:v>1533.6912</c:v>
                </c:pt>
                <c:pt idx="5">
                  <c:v>1498.9989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31-4098-BC0B-F6A927E152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4.4416112525057588E-2"/>
              <c:y val="0.1777939341726723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V$3</c:f>
              <c:strCache>
                <c:ptCount val="1"/>
                <c:pt idx="0">
                  <c:v>BR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V$13:$V$18</c:f>
                <c:numCache>
                  <c:formatCode>General</c:formatCode>
                  <c:ptCount val="6"/>
                  <c:pt idx="0">
                    <c:v>853.01750108008332</c:v>
                  </c:pt>
                  <c:pt idx="1">
                    <c:v>132.2132705188981</c:v>
                  </c:pt>
                  <c:pt idx="2">
                    <c:v>1115.1404228825238</c:v>
                  </c:pt>
                  <c:pt idx="3">
                    <c:v>469.51221789349637</c:v>
                  </c:pt>
                  <c:pt idx="4">
                    <c:v>579.4984707647036</c:v>
                  </c:pt>
                  <c:pt idx="5">
                    <c:v>707.00742226814214</c:v>
                  </c:pt>
                </c:numCache>
              </c:numRef>
            </c:plus>
            <c:minus>
              <c:numRef>
                <c:f>hybrids!$V$13:$V$18</c:f>
                <c:numCache>
                  <c:formatCode>General</c:formatCode>
                  <c:ptCount val="6"/>
                  <c:pt idx="0">
                    <c:v>853.01750108008332</c:v>
                  </c:pt>
                  <c:pt idx="1">
                    <c:v>132.2132705188981</c:v>
                  </c:pt>
                  <c:pt idx="2">
                    <c:v>1115.1404228825238</c:v>
                  </c:pt>
                  <c:pt idx="3">
                    <c:v>469.51221789349637</c:v>
                  </c:pt>
                  <c:pt idx="4">
                    <c:v>579.4984707647036</c:v>
                  </c:pt>
                  <c:pt idx="5">
                    <c:v>707.007422268142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V$4:$V$9</c:f>
              <c:numCache>
                <c:formatCode>0</c:formatCode>
                <c:ptCount val="6"/>
                <c:pt idx="0">
                  <c:v>4193.4994999999999</c:v>
                </c:pt>
                <c:pt idx="1">
                  <c:v>2245.2026333333333</c:v>
                </c:pt>
                <c:pt idx="2">
                  <c:v>2571.8638666666666</c:v>
                </c:pt>
                <c:pt idx="3">
                  <c:v>2470.6064999999999</c:v>
                </c:pt>
                <c:pt idx="4">
                  <c:v>1448.2421999999999</c:v>
                </c:pt>
                <c:pt idx="5">
                  <c:v>1767.2975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47-4AF9-9D3C-CF0504A991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4.3660206706232753E-2"/>
              <c:y val="0.213225168563400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brids!$W$3</c:f>
              <c:strCache>
                <c:ptCount val="1"/>
                <c:pt idx="0">
                  <c:v>NA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ybrids!$W$13:$W$18</c:f>
                <c:numCache>
                  <c:formatCode>General</c:formatCode>
                  <c:ptCount val="6"/>
                  <c:pt idx="0">
                    <c:v>2284.2623762011895</c:v>
                  </c:pt>
                  <c:pt idx="1">
                    <c:v>4977.0398028600339</c:v>
                  </c:pt>
                  <c:pt idx="2">
                    <c:v>2722.1610632963802</c:v>
                  </c:pt>
                  <c:pt idx="3">
                    <c:v>3779.0387316421302</c:v>
                  </c:pt>
                  <c:pt idx="4">
                    <c:v>3884.4511094388204</c:v>
                  </c:pt>
                  <c:pt idx="5">
                    <c:v>6159.7038031416214</c:v>
                  </c:pt>
                </c:numCache>
              </c:numRef>
            </c:plus>
            <c:minus>
              <c:numRef>
                <c:f>hybrids!$W$13:$W$18</c:f>
                <c:numCache>
                  <c:formatCode>General</c:formatCode>
                  <c:ptCount val="6"/>
                  <c:pt idx="0">
                    <c:v>2284.2623762011895</c:v>
                  </c:pt>
                  <c:pt idx="1">
                    <c:v>4977.0398028600339</c:v>
                  </c:pt>
                  <c:pt idx="2">
                    <c:v>2722.1610632963802</c:v>
                  </c:pt>
                  <c:pt idx="3">
                    <c:v>3779.0387316421302</c:v>
                  </c:pt>
                  <c:pt idx="4">
                    <c:v>3884.4511094388204</c:v>
                  </c:pt>
                  <c:pt idx="5">
                    <c:v>6159.70380314162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ybrids!$O$4:$O$9</c:f>
              <c:strCache>
                <c:ptCount val="6"/>
                <c:pt idx="0">
                  <c:v>FT-004</c:v>
                </c:pt>
                <c:pt idx="1">
                  <c:v>FT-086</c:v>
                </c:pt>
                <c:pt idx="2">
                  <c:v>Hy1</c:v>
                </c:pt>
                <c:pt idx="3">
                  <c:v>Hy2</c:v>
                </c:pt>
                <c:pt idx="4">
                  <c:v>Hy3</c:v>
                </c:pt>
                <c:pt idx="5">
                  <c:v>Hy4</c:v>
                </c:pt>
              </c:strCache>
            </c:strRef>
          </c:cat>
          <c:val>
            <c:numRef>
              <c:f>hybrids!$W$4:$W$9</c:f>
              <c:numCache>
                <c:formatCode>0</c:formatCode>
                <c:ptCount val="6"/>
                <c:pt idx="0">
                  <c:v>28671.803166666668</c:v>
                </c:pt>
                <c:pt idx="1">
                  <c:v>20044.903333333335</c:v>
                </c:pt>
                <c:pt idx="2">
                  <c:v>19485.134166666667</c:v>
                </c:pt>
                <c:pt idx="3">
                  <c:v>22603.965633333333</c:v>
                </c:pt>
                <c:pt idx="4">
                  <c:v>21703.130066666665</c:v>
                </c:pt>
                <c:pt idx="5">
                  <c:v>21259.421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CB-4DDC-B88A-B3E23DD13C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579056"/>
        <c:axId val="348581680"/>
      </c:barChart>
      <c:catAx>
        <c:axId val="34857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81680"/>
        <c:crosses val="autoZero"/>
        <c:auto val="1"/>
        <c:lblAlgn val="ctr"/>
        <c:lblOffset val="100"/>
        <c:noMultiLvlLbl val="0"/>
      </c:catAx>
      <c:valAx>
        <c:axId val="348581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700"/>
                  <a:t>Relative abundance (mass counts)</a:t>
                </a:r>
              </a:p>
            </c:rich>
          </c:tx>
          <c:layout>
            <c:manualLayout>
              <c:xMode val="edge"/>
              <c:yMode val="edge"/>
              <c:x val="3.5721987305099526E-2"/>
              <c:y val="0.142186335805245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34857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37341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65263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50893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51172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80825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029689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76320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89250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91828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30417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10479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DE81D-82D5-455B-B557-35F504B2188F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A745A-E1CF-49FA-9CBC-F6EC5C73574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80635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735140" y="2190069"/>
            <a:ext cx="2401887" cy="6902450"/>
            <a:chOff x="966788" y="1251285"/>
            <a:chExt cx="2401887" cy="6902450"/>
          </a:xfrm>
        </p:grpSpPr>
        <p:pic>
          <p:nvPicPr>
            <p:cNvPr id="2057" name="Picture 1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73" r="41327"/>
            <a:stretch>
              <a:fillRect/>
            </a:stretch>
          </p:blipFill>
          <p:spPr bwMode="auto">
            <a:xfrm>
              <a:off x="966788" y="1251285"/>
              <a:ext cx="2401887" cy="69024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 Box 2"/>
            <p:cNvSpPr txBox="1">
              <a:spLocks noChangeArrowheads="1"/>
            </p:cNvSpPr>
            <p:nvPr/>
          </p:nvSpPr>
          <p:spPr bwMode="auto">
            <a:xfrm>
              <a:off x="1128713" y="3114515"/>
              <a:ext cx="4953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nl-NL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Verdana" panose="020B060403050404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y1</a:t>
              </a:r>
              <a:endParaRPr kumimoji="0" lang="en-GB" altLang="nl-NL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081088" y="4236878"/>
              <a:ext cx="4953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nl-NL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Verdana" panose="020B060403050404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y2</a:t>
              </a:r>
              <a:endParaRPr kumimoji="0" lang="en-GB" altLang="nl-NL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" name="Text Box 6"/>
            <p:cNvSpPr txBox="1">
              <a:spLocks noChangeArrowheads="1"/>
            </p:cNvSpPr>
            <p:nvPr/>
          </p:nvSpPr>
          <p:spPr bwMode="auto">
            <a:xfrm>
              <a:off x="1100138" y="5510053"/>
              <a:ext cx="4953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nl-NL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Verdana" panose="020B060403050404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y3</a:t>
              </a:r>
              <a:endParaRPr kumimoji="0" lang="en-GB" altLang="nl-NL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Text Box 5"/>
            <p:cNvSpPr txBox="1">
              <a:spLocks noChangeArrowheads="1"/>
            </p:cNvSpPr>
            <p:nvPr/>
          </p:nvSpPr>
          <p:spPr bwMode="auto">
            <a:xfrm>
              <a:off x="1204913" y="6922928"/>
              <a:ext cx="4953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nl-NL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Verdana" panose="020B060403050404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y4</a:t>
              </a:r>
              <a:endParaRPr kumimoji="0" lang="en-GB" altLang="nl-NL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 flipH="1">
              <a:off x="1130331" y="7720931"/>
              <a:ext cx="0" cy="20955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 Box 3"/>
            <p:cNvSpPr txBox="1">
              <a:spLocks noChangeArrowheads="1"/>
            </p:cNvSpPr>
            <p:nvPr/>
          </p:nvSpPr>
          <p:spPr bwMode="auto">
            <a:xfrm>
              <a:off x="1115177" y="7750765"/>
              <a:ext cx="6477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nl-NL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Verdana" panose="020B060403050404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 cm</a:t>
              </a:r>
              <a:endParaRPr kumimoji="0" lang="en-GB" altLang="nl-NL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Text Box 2"/>
            <p:cNvSpPr txBox="1">
              <a:spLocks noChangeArrowheads="1"/>
            </p:cNvSpPr>
            <p:nvPr/>
          </p:nvSpPr>
          <p:spPr bwMode="auto">
            <a:xfrm>
              <a:off x="1076325" y="2228690"/>
              <a:ext cx="733425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Verdana" panose="020B060403050404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T-086</a:t>
              </a:r>
              <a:endParaRPr kumimoji="0" lang="nl-NL" altLang="nl-NL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Text Box 1"/>
            <p:cNvSpPr txBox="1">
              <a:spLocks noChangeArrowheads="1"/>
            </p:cNvSpPr>
            <p:nvPr/>
          </p:nvSpPr>
          <p:spPr bwMode="auto">
            <a:xfrm>
              <a:off x="1076325" y="1517490"/>
              <a:ext cx="733425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altLang="nl-NL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Verdana" panose="020B060403050404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T-004</a:t>
              </a:r>
              <a:endParaRPr kumimoji="0" lang="nl-NL" altLang="nl-NL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2" name="Rectangle 10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nl-NL"/>
          </a:p>
        </p:txBody>
      </p:sp>
      <p:sp>
        <p:nvSpPr>
          <p:cNvPr id="13" name="Rectangle 18"/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nl-NL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Verdana" panose="020B060403050404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n-GB" altLang="nl-NL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Verdana" panose="020B060403050404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kumimoji="0" lang="en-GB" altLang="nl-NL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05326" y="457200"/>
            <a:ext cx="604177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Supplemental Figure F2</a:t>
            </a:r>
            <a:endParaRPr lang="nl-NL" sz="1400" dirty="0"/>
          </a:p>
          <a:p>
            <a:r>
              <a:rPr lang="en-GB" sz="1400" dirty="0"/>
              <a:t>Tubers from four crosses between FT-004 and FT-086. Shown are representative turnip tubers from parents and F1 (Hy1 to Hy4) at 41 days after sowing. Bar diagrams represent relative intensities of individual </a:t>
            </a:r>
            <a:r>
              <a:rPr lang="en-GB" sz="1400" dirty="0" err="1"/>
              <a:t>glucosinolates</a:t>
            </a:r>
            <a:r>
              <a:rPr lang="en-GB" sz="1400" dirty="0"/>
              <a:t>. Error bars represent standard deviations (n=3 biological replicates)</a:t>
            </a:r>
            <a:endParaRPr lang="nl-NL" sz="1400" dirty="0"/>
          </a:p>
          <a:p>
            <a:endParaRPr lang="nl-NL" sz="1400" dirty="0"/>
          </a:p>
        </p:txBody>
      </p:sp>
    </p:spTree>
    <p:extLst>
      <p:ext uri="{BB962C8B-B14F-4D97-AF65-F5344CB8AC3E}">
        <p14:creationId xmlns:p14="http://schemas.microsoft.com/office/powerpoint/2010/main" val="39291183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6561180"/>
              </p:ext>
            </p:extLst>
          </p:nvPr>
        </p:nvGraphicFramePr>
        <p:xfrm>
          <a:off x="53641" y="5003619"/>
          <a:ext cx="3394409" cy="1659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975817"/>
              </p:ext>
            </p:extLst>
          </p:nvPr>
        </p:nvGraphicFramePr>
        <p:xfrm>
          <a:off x="3572114" y="5032194"/>
          <a:ext cx="3187454" cy="1659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5464444"/>
              </p:ext>
            </p:extLst>
          </p:nvPr>
        </p:nvGraphicFramePr>
        <p:xfrm>
          <a:off x="120316" y="3199392"/>
          <a:ext cx="3394409" cy="1659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9642435"/>
              </p:ext>
            </p:extLst>
          </p:nvPr>
        </p:nvGraphicFramePr>
        <p:xfrm>
          <a:off x="3562589" y="3208917"/>
          <a:ext cx="3187454" cy="1659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9825653"/>
              </p:ext>
            </p:extLst>
          </p:nvPr>
        </p:nvGraphicFramePr>
        <p:xfrm>
          <a:off x="120316" y="1491912"/>
          <a:ext cx="3394409" cy="1659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3482194"/>
              </p:ext>
            </p:extLst>
          </p:nvPr>
        </p:nvGraphicFramePr>
        <p:xfrm>
          <a:off x="3562589" y="1482387"/>
          <a:ext cx="3187454" cy="1659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1775802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0284742"/>
              </p:ext>
            </p:extLst>
          </p:nvPr>
        </p:nvGraphicFramePr>
        <p:xfrm>
          <a:off x="283744" y="648703"/>
          <a:ext cx="3145255" cy="17922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5772726"/>
              </p:ext>
            </p:extLst>
          </p:nvPr>
        </p:nvGraphicFramePr>
        <p:xfrm>
          <a:off x="283745" y="2628903"/>
          <a:ext cx="3199710" cy="17922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7021722"/>
              </p:ext>
            </p:extLst>
          </p:nvPr>
        </p:nvGraphicFramePr>
        <p:xfrm>
          <a:off x="301475" y="4554637"/>
          <a:ext cx="3199710" cy="17944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930838"/>
              </p:ext>
            </p:extLst>
          </p:nvPr>
        </p:nvGraphicFramePr>
        <p:xfrm>
          <a:off x="3501185" y="648703"/>
          <a:ext cx="3145255" cy="17922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5836424"/>
              </p:ext>
            </p:extLst>
          </p:nvPr>
        </p:nvGraphicFramePr>
        <p:xfrm>
          <a:off x="3501186" y="2628903"/>
          <a:ext cx="3199710" cy="17922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086086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149</Words>
  <Application>Microsoft Office PowerPoint</Application>
  <PresentationFormat>A4 Paper (210x297 mm)</PresentationFormat>
  <Paragraphs>3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Verdana</vt:lpstr>
      <vt:lpstr>Office Theme</vt:lpstr>
      <vt:lpstr>PowerPoint Presentation</vt:lpstr>
      <vt:lpstr>PowerPoint Presentation</vt:lpstr>
      <vt:lpstr>PowerPoint Presentation</vt:lpstr>
    </vt:vector>
  </TitlesOfParts>
  <Company>Wageningen University and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ekwilder, Jules</dc:creator>
  <cp:lastModifiedBy>Beekwilder, Jules</cp:lastModifiedBy>
  <cp:revision>4</cp:revision>
  <dcterms:created xsi:type="dcterms:W3CDTF">2019-04-26T11:31:26Z</dcterms:created>
  <dcterms:modified xsi:type="dcterms:W3CDTF">2019-05-22T15:43:30Z</dcterms:modified>
</cp:coreProperties>
</file>